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notesMasterIdLst>
    <p:notesMasterId r:id="rId11"/>
  </p:notesMasterIdLst>
  <p:sldIdLst>
    <p:sldId id="363" r:id="rId2"/>
    <p:sldId id="364" r:id="rId3"/>
    <p:sldId id="365" r:id="rId4"/>
    <p:sldId id="366" r:id="rId5"/>
    <p:sldId id="367" r:id="rId6"/>
    <p:sldId id="368" r:id="rId7"/>
    <p:sldId id="369" r:id="rId8"/>
    <p:sldId id="370" r:id="rId9"/>
    <p:sldId id="371" r:id="rId10"/>
  </p:sldIdLst>
  <p:sldSz cx="1800066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F37"/>
    <a:srgbClr val="FF0066"/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26" autoAdjust="0"/>
    <p:restoredTop sz="94660"/>
  </p:normalViewPr>
  <p:slideViewPr>
    <p:cSldViewPr snapToGrid="0">
      <p:cViewPr varScale="1">
        <p:scale>
          <a:sx n="51" d="100"/>
          <a:sy n="51" d="100"/>
        </p:scale>
        <p:origin x="30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6EDD6-3258-440A-9902-2789A42D8DF4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FBEFC9-5CE1-484F-A54A-086BADF5F3AC}" type="slidenum">
              <a:rPr lang="en-ZA" smtClean="0"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1pPr>
    <a:lvl2pPr marL="777531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2pPr>
    <a:lvl3pPr marL="1555064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3pPr>
    <a:lvl4pPr marL="2332594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4pPr>
    <a:lvl5pPr marL="3110125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5pPr>
    <a:lvl6pPr marL="3887658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6pPr>
    <a:lvl7pPr marL="4665189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7pPr>
    <a:lvl8pPr marL="5442722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8pPr>
    <a:lvl9pPr marL="6220253" algn="l" defTabSz="1555064" rtl="0" eaLnBrk="1" latinLnBrk="0" hangingPunct="1">
      <a:defRPr sz="204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</p:spPr>
      </p:sp>
      <p:sp>
        <p:nvSpPr>
          <p:cNvPr id="3" name="Text Placeholder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</p:spPr>
      </p:sp>
      <p:sp>
        <p:nvSpPr>
          <p:cNvPr id="3" name="Text Placeholder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356703"/>
            <a:ext cx="15300564" cy="501340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563446"/>
            <a:ext cx="13500497" cy="347671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4765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4837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66678"/>
            <a:ext cx="3881393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66678"/>
            <a:ext cx="11419171" cy="1220351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45074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99513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90057"/>
            <a:ext cx="15525572" cy="59900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636813"/>
            <a:ext cx="15525572" cy="315004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99309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833390"/>
            <a:ext cx="7650282" cy="91368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833390"/>
            <a:ext cx="7650282" cy="913680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16705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66681"/>
            <a:ext cx="15525572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530053"/>
            <a:ext cx="7615123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260078"/>
            <a:ext cx="7615123" cy="773678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530053"/>
            <a:ext cx="7652626" cy="173002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260078"/>
            <a:ext cx="7652626" cy="773678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03635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09133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51633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73367"/>
            <a:ext cx="9112836" cy="10233485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95816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60014"/>
            <a:ext cx="5805682" cy="336005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73367"/>
            <a:ext cx="9112836" cy="10233485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320064"/>
            <a:ext cx="5805682" cy="8003453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66528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66681"/>
            <a:ext cx="1552557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833390"/>
            <a:ext cx="1552557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2FB08-5CC3-4D72-A594-73335DA12CC5}" type="datetimeFigureOut">
              <a:rPr lang="en-ZA" smtClean="0"/>
              <a:t>2020/06/2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346867"/>
            <a:ext cx="607522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346867"/>
            <a:ext cx="4050149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FDE514-504D-4E57-A7D0-F3D9CEA8720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69784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>
                <a:latin typeface="Arial" panose="020B0604020202020204" pitchFamily="34" charset="0"/>
                <a:cs typeface="Arial" panose="020B0604020202020204" pitchFamily="34" charset="0"/>
              </a:rPr>
              <a:t>Supplementary – Table S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404755"/>
              </p:ext>
            </p:extLst>
          </p:nvPr>
        </p:nvGraphicFramePr>
        <p:xfrm>
          <a:off x="1242695" y="1082567"/>
          <a:ext cx="15515271" cy="12235078"/>
        </p:xfrm>
        <a:graphic>
          <a:graphicData uri="http://schemas.openxmlformats.org/drawingml/2006/table">
            <a:tbl>
              <a:tblPr firstRow="1" firstCol="1" bandRow="1"/>
              <a:tblGrid>
                <a:gridCol w="102074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282262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792566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16160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372061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120" marR="80120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 Genes </a:t>
                      </a:r>
                    </a:p>
                  </a:txBody>
                  <a:tcPr marL="80120" marR="80120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206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54266" marR="54266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  <a:endParaRPr lang="en-ZA" sz="18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6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6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,5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9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,8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78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0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4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6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2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3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2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6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6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7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7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1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2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0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0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2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9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7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3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2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2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0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6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5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4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5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0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1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9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0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1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2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4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3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7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1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0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3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4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1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8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9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5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3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2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6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8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6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1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7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9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2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6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0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3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9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3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9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7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9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8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3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3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6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6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6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8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2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7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1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2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1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8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6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5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5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3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4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7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3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1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2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4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1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3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8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3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7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1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1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7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2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X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3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8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9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6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buNone/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1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ZA" alt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1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X or Y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ZA" alt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ZA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39863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2032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250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992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325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4599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845938">
                <a:tc gridSpan="1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The sex chromosomes are shaded in grey as the samples were not adjusted for gender, hence there was not equal representation of the X or Y chromosomes in comparison to the autosomal chromosomes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# genes per chromosome sourced from </a:t>
                      </a:r>
                      <a:r>
                        <a:rPr lang="en-ZA" sz="1800" b="0" dirty="0" err="1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Ensembl</a:t>
                      </a: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 2018, release 9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</a:tbl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D1A22C43-40EA-42BE-B25D-B17062508B21}"/>
              </a:ext>
            </a:extLst>
          </p:cNvPr>
          <p:cNvSpPr/>
          <p:nvPr/>
        </p:nvSpPr>
        <p:spPr>
          <a:xfrm>
            <a:off x="0" y="36585"/>
            <a:ext cx="3520516" cy="71776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4000" dirty="0">
                <a:latin typeface="Arial" panose="020B06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Filtered Reads</a:t>
            </a:r>
            <a:endParaRPr lang="en-ZA" sz="40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149005059"/>
              </p:ext>
            </p:extLst>
          </p:nvPr>
        </p:nvGraphicFramePr>
        <p:xfrm>
          <a:off x="1237544" y="1082497"/>
          <a:ext cx="15525573" cy="12235218"/>
        </p:xfrm>
        <a:graphic>
          <a:graphicData uri="http://schemas.openxmlformats.org/drawingml/2006/table">
            <a:tbl>
              <a:tblPr firstRow="1" firstCol="1" bandRow="1"/>
              <a:tblGrid>
                <a:gridCol w="102191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825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834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8254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8348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8254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8348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8348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28254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28348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793504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162543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372061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0120" marR="80120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 Genes </a:t>
                      </a:r>
                    </a:p>
                  </a:txBody>
                  <a:tcPr marL="80120" marR="80120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22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54266" marR="54266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  <a:endParaRPr lang="en-ZA" sz="1800" b="1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,2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,5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,6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78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6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6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8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32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6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7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1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2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7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2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2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,6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3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4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1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9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0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4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9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47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6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3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1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5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8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1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9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4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3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3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6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9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3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8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6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8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8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,8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1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7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28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3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7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0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2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,1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4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8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4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3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1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9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6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2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X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8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6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buNone/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Y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1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X or Y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ZA" sz="1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39863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83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9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206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845938">
                <a:tc gridSpan="12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The sex chromosomes are shaded in grey as the samples were not adjusted for gender, hence there was not equal representation of the X or Y chromosomes in comparison to the autosomal chromosomes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# genes per chromosome sourced from </a:t>
                      </a:r>
                      <a:r>
                        <a:rPr lang="en-ZA" sz="1800" b="0" dirty="0" err="1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Ensembl</a:t>
                      </a: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ea typeface="DFKai-SB" panose="03000509000000000000" pitchFamily="65" charset="-120"/>
                          <a:cs typeface="Arial" panose="020B0604020202020204" pitchFamily="34" charset="0"/>
                        </a:rPr>
                        <a:t> 2018, release 91</a:t>
                      </a:r>
                    </a:p>
                  </a:txBody>
                  <a:tcPr marL="15945" marR="15945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>
                      <a:noFill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10800" marR="10800" marT="0" marB="0" anchor="ctr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00884721-72FE-4E76-B4F6-8C7F854F2567}"/>
              </a:ext>
            </a:extLst>
          </p:cNvPr>
          <p:cNvSpPr/>
          <p:nvPr/>
        </p:nvSpPr>
        <p:spPr>
          <a:xfrm>
            <a:off x="0" y="0"/>
            <a:ext cx="3948517" cy="71776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4000" dirty="0">
                <a:latin typeface="Arial" panose="020B06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Authentic Reads</a:t>
            </a:r>
            <a:endParaRPr lang="en-ZA" sz="40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>
                <a:latin typeface="Arial" panose="020B0604020202020204" pitchFamily="34" charset="0"/>
                <a:cs typeface="Arial" panose="020B0604020202020204" pitchFamily="34" charset="0"/>
              </a:rPr>
              <a:t>Supplementary - Table S2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5008821"/>
              </p:ext>
            </p:extLst>
          </p:nvPr>
        </p:nvGraphicFramePr>
        <p:xfrm>
          <a:off x="1253617" y="1842184"/>
          <a:ext cx="15493427" cy="10715844"/>
        </p:xfrm>
        <a:graphic>
          <a:graphicData uri="http://schemas.openxmlformats.org/drawingml/2006/table">
            <a:tbl>
              <a:tblPr firstRow="1" firstCol="1" bandRow="1"/>
              <a:tblGrid>
                <a:gridCol w="31211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237224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3722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22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' LT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1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5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5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35 to 789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1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1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8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2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GAG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5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2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5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2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3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GAG/POL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0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0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POL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,9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,9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9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0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,9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POL/VIF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6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3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8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1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IF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1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6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IF/VP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9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6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8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6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1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1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2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R/TAT ncl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7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7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8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R/TAT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2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1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TAT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5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3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TAT/RE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4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8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7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1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Upstream VPU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1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1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U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0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8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5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3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U/EN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0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3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4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6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N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0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7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7,8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,7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2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,6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6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,7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NV/RE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,6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,8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,1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6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1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6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NV/REV/TAT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7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6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8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0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NEF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8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2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7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,5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0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4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NEF/3' LT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5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6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,7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9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1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' LT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,8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3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8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86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3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,3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3825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ZA" sz="1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01254" marR="101254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ZA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9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ZA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2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ZA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3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99</a:t>
                      </a:r>
                    </a:p>
                  </a:txBody>
                  <a:tcPr marL="14063" marR="14063" marT="14063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ZA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556990">
                <a:tc gridSpan="11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5 to 789: nucleotides 635 to 789, the region before 5’ LTR and </a:t>
                      </a:r>
                      <a:r>
                        <a:rPr lang="en-ZA" sz="1800" b="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</a:t>
                      </a: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location of SD1 sites</a:t>
                      </a:r>
                    </a:p>
                  </a:txBody>
                  <a:tcPr marL="101254" marR="101254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F58B4A59-3B2B-4AEA-B3AC-05518FD95854}"/>
              </a:ext>
            </a:extLst>
          </p:cNvPr>
          <p:cNvSpPr/>
          <p:nvPr/>
        </p:nvSpPr>
        <p:spPr>
          <a:xfrm>
            <a:off x="0" y="0"/>
            <a:ext cx="3520516" cy="71776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4000" dirty="0">
                <a:latin typeface="Arial" panose="020B06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Filtered Reads</a:t>
            </a:r>
            <a:endParaRPr lang="en-ZA" sz="40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10379040"/>
              </p:ext>
            </p:extLst>
          </p:nvPr>
        </p:nvGraphicFramePr>
        <p:xfrm>
          <a:off x="1237545" y="1842184"/>
          <a:ext cx="15525571" cy="10715844"/>
        </p:xfrm>
        <a:graphic>
          <a:graphicData uri="http://schemas.openxmlformats.org/drawingml/2006/table">
            <a:tbl>
              <a:tblPr firstRow="1" firstCol="1" bandRow="1"/>
              <a:tblGrid>
                <a:gridCol w="31276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3848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3848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23942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239421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3722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22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%</a:t>
                      </a:r>
                    </a:p>
                  </a:txBody>
                  <a:tcPr marL="101254" marR="101254" marT="0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' LT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,0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,6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,2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35 to 789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,0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4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,3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GAG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1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GAG/POL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POL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,3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POL/VIF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IF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IF/VP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R/TAT ncl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R/TAT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TAT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TAT/RE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8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8,57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85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Upstream VPU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U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1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U/EN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N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1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,9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NV/RE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4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NV/REV/TAT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NEF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NEF/3' LT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1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,29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2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,4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' LT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4,00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1,08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7,14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6,92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9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2,33 </a:t>
                      </a:r>
                    </a:p>
                  </a:txBody>
                  <a:tcPr marL="135005" marR="135005" marT="67502" marB="67502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3825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ZA" sz="1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01254" marR="101254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ZA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ZA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ZA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ZA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6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ZA" sz="1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4063" marR="14063" marT="14063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556990">
                <a:tc gridSpan="11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5 to 789: nucleotides 635 to 789, the region before 5’ LTR and </a:t>
                      </a:r>
                      <a:r>
                        <a:rPr lang="en-ZA" sz="1800" b="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</a:t>
                      </a: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location of SD1 sites</a:t>
                      </a:r>
                    </a:p>
                  </a:txBody>
                  <a:tcPr marL="101254" marR="101254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8BD92118-84DE-4412-A120-25267F1F9344}"/>
              </a:ext>
            </a:extLst>
          </p:cNvPr>
          <p:cNvSpPr/>
          <p:nvPr/>
        </p:nvSpPr>
        <p:spPr>
          <a:xfrm>
            <a:off x="0" y="0"/>
            <a:ext cx="4091185" cy="71776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4000" dirty="0">
                <a:latin typeface="Arial" panose="020B06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Authentic Reads</a:t>
            </a:r>
            <a:endParaRPr lang="en-ZA" sz="40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ZA" dirty="0">
                <a:latin typeface="Arial" panose="020B0604020202020204" pitchFamily="34" charset="0"/>
                <a:cs typeface="Arial" panose="020B0604020202020204" pitchFamily="34" charset="0"/>
              </a:rPr>
              <a:t>Supplementary - Table S3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37820805"/>
              </p:ext>
            </p:extLst>
          </p:nvPr>
        </p:nvGraphicFramePr>
        <p:xfrm>
          <a:off x="4337034" y="3316444"/>
          <a:ext cx="9326593" cy="7767323"/>
        </p:xfrm>
        <a:graphic>
          <a:graphicData uri="http://schemas.openxmlformats.org/drawingml/2006/table">
            <a:tbl>
              <a:tblPr firstRow="1" firstCol="1" bandRow="1"/>
              <a:tblGrid>
                <a:gridCol w="31276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3848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3942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22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' LT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35 to 789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GAG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9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6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POL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32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8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IF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1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8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TAT </a:t>
                      </a:r>
                      <a:r>
                        <a:rPr lang="en-ZA" alt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xon 2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ZA" alt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REV Exon 2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Upstream VPU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U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1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NV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0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25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37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ZA" alt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REV Exon 3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ZA" alt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TAT Exon 3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7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NEF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2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92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9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' LTR</a:t>
                      </a:r>
                    </a:p>
                  </a:txBody>
                  <a:tcPr marL="135005" marR="135005" marT="67502" marB="67502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8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79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2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825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ZA" sz="1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01254" marR="101254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9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4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89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386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21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845938">
                <a:tc gridSpan="6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5 to 789: nucleotides 635 to 789, the region before 5’ LTR and </a:t>
                      </a:r>
                      <a:r>
                        <a:rPr lang="en-ZA" sz="1800" b="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</a:t>
                      </a: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location of SD1 sites</a:t>
                      </a:r>
                    </a:p>
                  </a:txBody>
                  <a:tcPr marL="101254" marR="101254" marT="0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BC10F1E1-DC5B-436C-91DF-8844E1B3BC4D}"/>
              </a:ext>
            </a:extLst>
          </p:cNvPr>
          <p:cNvSpPr/>
          <p:nvPr/>
        </p:nvSpPr>
        <p:spPr>
          <a:xfrm>
            <a:off x="0" y="0"/>
            <a:ext cx="3520516" cy="71776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4000" dirty="0">
                <a:latin typeface="Arial" panose="020B06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Filtered Reads</a:t>
            </a:r>
            <a:endParaRPr lang="en-ZA" sz="40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855633473"/>
              </p:ext>
            </p:extLst>
          </p:nvPr>
        </p:nvGraphicFramePr>
        <p:xfrm>
          <a:off x="4337034" y="3316444"/>
          <a:ext cx="9326593" cy="7767323"/>
        </p:xfrm>
        <a:graphic>
          <a:graphicData uri="http://schemas.openxmlformats.org/drawingml/2006/table">
            <a:tbl>
              <a:tblPr firstRow="1" firstCol="1" bandRow="1"/>
              <a:tblGrid>
                <a:gridCol w="31276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3848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4035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3942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2201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en-ZA" sz="1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01254" marR="101254" marT="0" marB="0" anchor="b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>
                      <a:noFill/>
                      <a:prstDash val="soli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>
                      <a:noFill/>
                      <a:prstDash val="soli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6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>
                      <a:noFill/>
                      <a:prstDash val="soli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 marL="101254" marR="101254" marT="0" marB="0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>
                      <a:noFill/>
                      <a:prstDash val="soli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ZA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01254" marR="101254" marT="0" marB="0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 w="28575">
                      <a:noFill/>
                      <a:prstDash val="soli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' LTR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35 to 789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GAG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POL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IF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R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TAT </a:t>
                      </a:r>
                      <a:r>
                        <a:rPr lang="en-ZA" alt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xon 2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ZA" alt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REV Exon 2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Upstream VPU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VPU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ENV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ZA" alt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REV Exon 3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ZA" alt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TAT Exon 3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NEF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405015"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1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3' LTR</a:t>
                      </a:r>
                    </a:p>
                  </a:txBody>
                  <a:tcPr marL="135005" marR="135005" marT="67502" marB="67502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6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61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72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54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82514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ZA" sz="1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</a:p>
                  </a:txBody>
                  <a:tcPr marL="101254" marR="101254" marT="0" marB="0" anchor="ctr">
                    <a:lnL w="28575">
                      <a:noFill/>
                      <a:prstDash val="soli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89</a:t>
                      </a:r>
                    </a:p>
                  </a:txBody>
                  <a:tcPr marL="135005" marR="135005" marT="67502" marB="67502" anchor="b"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95</a:t>
                      </a:r>
                    </a:p>
                  </a:txBody>
                  <a:tcPr marL="135005" marR="135005" marT="67502" marB="67502" anchor="b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800" b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</a:rPr>
                        <a:t>221</a:t>
                      </a:r>
                    </a:p>
                  </a:txBody>
                  <a:tcPr marL="135005" marR="135005" marT="67502" marB="67502" anchor="b">
                    <a:lnL w="28575">
                      <a:noFill/>
                      <a:prstDash val="solid"/>
                    </a:lnL>
                    <a:lnR w="28575">
                      <a:noFill/>
                      <a:prstDash val="soli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845938">
                <a:tc gridSpan="6"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</a:pP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5 to 789: nucleotides 635 to 789, the region before 5’ LTR and </a:t>
                      </a:r>
                      <a:r>
                        <a:rPr lang="en-ZA" sz="1800" b="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</a:t>
                      </a:r>
                      <a:r>
                        <a:rPr lang="en-ZA" sz="18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location of SD1 sites</a:t>
                      </a:r>
                    </a:p>
                  </a:txBody>
                  <a:tcPr marL="101254" marR="10125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>
                      <a:solidFill>
                        <a:schemeClr val="tx1"/>
                      </a:solidFill>
                      <a:prstDash val="soli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EE36369C-A4C1-41B5-BCEA-310057A51D67}"/>
              </a:ext>
            </a:extLst>
          </p:cNvPr>
          <p:cNvSpPr/>
          <p:nvPr/>
        </p:nvSpPr>
        <p:spPr>
          <a:xfrm>
            <a:off x="0" y="0"/>
            <a:ext cx="3948517" cy="71776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ZA" sz="4000" dirty="0">
                <a:latin typeface="Arial" panose="020B060402020202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Authentic Reads</a:t>
            </a:r>
            <a:endParaRPr lang="en-ZA" sz="40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632</Words>
  <Application>Microsoft Office PowerPoint</Application>
  <PresentationFormat>Custom</PresentationFormat>
  <Paragraphs>1391</Paragraphs>
  <Slides>9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DFKai-SB</vt:lpstr>
      <vt:lpstr>新細明體</vt:lpstr>
      <vt:lpstr>Arial</vt:lpstr>
      <vt:lpstr>Calibri</vt:lpstr>
      <vt:lpstr>Calibri Light</vt:lpstr>
      <vt:lpstr>Times New Roman</vt:lpstr>
      <vt:lpstr>1_Office Theme</vt:lpstr>
      <vt:lpstr>Supplementary – Table S1</vt:lpstr>
      <vt:lpstr>PowerPoint Presentation</vt:lpstr>
      <vt:lpstr>PowerPoint Presentation</vt:lpstr>
      <vt:lpstr>Supplementary - Table S2</vt:lpstr>
      <vt:lpstr>PowerPoint Presentation</vt:lpstr>
      <vt:lpstr>PowerPoint Presentation</vt:lpstr>
      <vt:lpstr>Supplementary - Table S3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elle Lee</dc:creator>
  <cp:lastModifiedBy>Lee, Michelle</cp:lastModifiedBy>
  <cp:revision>79</cp:revision>
  <dcterms:created xsi:type="dcterms:W3CDTF">2017-09-16T03:18:00Z</dcterms:created>
  <dcterms:modified xsi:type="dcterms:W3CDTF">2020-06-28T17:3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7646</vt:lpwstr>
  </property>
</Properties>
</file>